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5">
  <p:sldMasterIdLst>
    <p:sldMasterId id="2147483648" r:id="rId1"/>
  </p:sldMasterIdLst>
  <p:notesMasterIdLst>
    <p:notesMasterId r:id="rId3"/>
  </p:notesMasterIdLst>
  <p:sldIdLst>
    <p:sldId id="36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18CDF"/>
    <a:srgbClr val="16A8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749" autoAdjust="0"/>
    <p:restoredTop sz="88454" autoAdjust="0"/>
  </p:normalViewPr>
  <p:slideViewPr>
    <p:cSldViewPr>
      <p:cViewPr varScale="1">
        <p:scale>
          <a:sx n="85" d="100"/>
          <a:sy n="85" d="100"/>
        </p:scale>
        <p:origin x="2886" y="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2FAFD0-EF8C-554B-B034-4442DE591FA0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B1FB10-D472-764B-87F9-C134BDEA3E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81839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0638899-136A-09D5-100F-E4C4063BCB4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40FFE61D-9C37-1482-0A07-D3B65FE4A03F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D9F814AD-77A0-8672-355B-45AF1647A0B8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15128CC-008D-19F7-D27B-FF00B2B4FC77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CB1FB10-D472-764B-87F9-C134BDEA3E1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74700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81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14337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8408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8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8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2487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8122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3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80949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1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1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7935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25369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91372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465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1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7" y="36408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10" y="191348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1396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8140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1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4334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B8CE289-A357-B2AA-5E01-F450F9A80F0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202A6B64-99EB-CD80-47BD-ADAD4E38EAD2}"/>
              </a:ext>
            </a:extLst>
          </p:cNvPr>
          <p:cNvSpPr txBox="1"/>
          <p:nvPr/>
        </p:nvSpPr>
        <p:spPr>
          <a:xfrm>
            <a:off x="76200" y="6629400"/>
            <a:ext cx="6705600" cy="19389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/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10. a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chematic overview of the procedures for generating human iPSCs-derived organoids from AD patients.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-e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Levels of extracellular Aβ40 (b) and Aβ42 (c) and intracellular Aβ40 (d) and Aβ42 (e) measured using ELISA in Vehicle or C458-treated iPSC-derived organoids from AD patients.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-</a:t>
            </a:r>
            <a:r>
              <a:rPr lang="en-US" sz="12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Levels of extracellular Aβ40 (f) and Aβ42 (g) and intracellular Aβ40 (h) and Aβ42 (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measured using ELISA in Vehicle or CP2-treated iPSC-derived organoids from AD patients.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j-m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Levels of total tau and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Tau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181 in the RIPA lysates of 3 cerebral organoids treated with C458 (j-k) and CP2 (l-m) analyzed using ELISA. Lysates of 3 cerebral organoids per iPSC line were analyzed at week 12 in culture. Data are mean ± SD. * </a:t>
            </a:r>
            <a:r>
              <a:rPr lang="en-US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&lt; 0.05; **</a:t>
            </a:r>
            <a:r>
              <a:rPr lang="en-US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&lt; 0.01; ***</a:t>
            </a:r>
            <a:r>
              <a:rPr lang="en-US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&lt; 0.001, ****</a:t>
            </a:r>
            <a:r>
              <a:rPr lang="en-US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&lt;0.0001, ns, not significant. 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L="0" marR="0" lvl="0" indent="0" algn="just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07AC3C3-BE97-D226-898E-FAD787A27B2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7201" y="309325"/>
            <a:ext cx="6022238" cy="61676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00359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50713</TotalTime>
  <Words>172</Words>
  <Application>Microsoft Office PowerPoint</Application>
  <PresentationFormat>On-screen Show (4:3)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rgey A Trushin</dc:creator>
  <cp:lastModifiedBy>Trushin, Sergey A., Ph.D.</cp:lastModifiedBy>
  <cp:revision>604</cp:revision>
  <cp:lastPrinted>2022-11-09T15:46:24Z</cp:lastPrinted>
  <dcterms:created xsi:type="dcterms:W3CDTF">2020-01-31T17:27:01Z</dcterms:created>
  <dcterms:modified xsi:type="dcterms:W3CDTF">2025-02-12T20:36:23Z</dcterms:modified>
</cp:coreProperties>
</file>